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54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23956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274259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20839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993234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946849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6533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42452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181728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622230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32223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132893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2FC5E-4AD0-4E9A-8383-29AEE046C5E5}" type="datetimeFigureOut">
              <a:rPr lang="en-SE" smtClean="0"/>
              <a:t>2019-03-05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E678B-A866-4EE9-806B-36B9051D29E0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524242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slideLayout" Target="../slideLayouts/slideLayout1.xml"/><Relationship Id="rId18" Type="http://schemas.openxmlformats.org/officeDocument/2006/relationships/image" Target="../media/image5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video" Target="../media/media6.mp4"/><Relationship Id="rId17" Type="http://schemas.openxmlformats.org/officeDocument/2006/relationships/image" Target="../media/image4.png"/><Relationship Id="rId2" Type="http://schemas.openxmlformats.org/officeDocument/2006/relationships/video" Target="../media/media1.mp4"/><Relationship Id="rId16" Type="http://schemas.openxmlformats.org/officeDocument/2006/relationships/image" Target="../media/image3.png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microsoft.com/office/2007/relationships/media" Target="../media/media6.mp4"/><Relationship Id="rId5" Type="http://schemas.microsoft.com/office/2007/relationships/media" Target="../media/media3.mp4"/><Relationship Id="rId15" Type="http://schemas.openxmlformats.org/officeDocument/2006/relationships/image" Target="../media/image2.png"/><Relationship Id="rId10" Type="http://schemas.openxmlformats.org/officeDocument/2006/relationships/video" Target="../media/media5.mp4"/><Relationship Id="rId19" Type="http://schemas.openxmlformats.org/officeDocument/2006/relationships/image" Target="../media/image6.png"/><Relationship Id="rId4" Type="http://schemas.openxmlformats.org/officeDocument/2006/relationships/video" Target="../media/media2.mp4"/><Relationship Id="rId9" Type="http://schemas.microsoft.com/office/2007/relationships/media" Target="../media/media5.mp4"/><Relationship Id="rId1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M7 60Um.C12 timelapse">
            <a:hlinkClick r:id="" action="ppaction://media"/>
            <a:extLst>
              <a:ext uri="{FF2B5EF4-FFF2-40B4-BE49-F238E27FC236}">
                <a16:creationId xmlns:a16="http://schemas.microsoft.com/office/drawing/2014/main" id="{F2B735DC-2815-4AB5-AD74-42577669E9F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14">
            <a:lum contrast="20000"/>
          </a:blip>
          <a:srcRect l="11075" t="23860" r="11184" b="23470"/>
          <a:stretch>
            <a:fillRect/>
          </a:stretch>
        </p:blipFill>
        <p:spPr>
          <a:xfrm>
            <a:off x="633488" y="4747956"/>
            <a:ext cx="3828862" cy="1924186"/>
          </a:xfrm>
          <a:prstGeom prst="rect">
            <a:avLst/>
          </a:prstGeom>
        </p:spPr>
      </p:pic>
      <p:pic>
        <p:nvPicPr>
          <p:cNvPr id="48" name="M7 60Um.C12 Zstack2-1">
            <a:hlinkClick r:id="" action="ppaction://media"/>
            <a:extLst>
              <a:ext uri="{FF2B5EF4-FFF2-40B4-BE49-F238E27FC236}">
                <a16:creationId xmlns:a16="http://schemas.microsoft.com/office/drawing/2014/main" id="{CC5F709A-ACB4-4CB1-A12B-390987E03D43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15">
            <a:lum contrast="20000"/>
          </a:blip>
          <a:srcRect t="3015" r="3048" b="32151"/>
          <a:stretch>
            <a:fillRect/>
          </a:stretch>
        </p:blipFill>
        <p:spPr>
          <a:xfrm>
            <a:off x="5046115" y="4745692"/>
            <a:ext cx="3828863" cy="1909713"/>
          </a:xfrm>
          <a:prstGeom prst="rect">
            <a:avLst/>
          </a:prstGeom>
        </p:spPr>
      </p:pic>
      <p:pic>
        <p:nvPicPr>
          <p:cNvPr id="5" name="M7_DMSO_timeseries2">
            <a:hlinkClick r:id="" action="ppaction://media"/>
            <a:extLst>
              <a:ext uri="{FF2B5EF4-FFF2-40B4-BE49-F238E27FC236}">
                <a16:creationId xmlns:a16="http://schemas.microsoft.com/office/drawing/2014/main" id="{C07878FB-0E78-4292-B9C6-AC0A625E1B84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6">
            <a:lum contrast="20000"/>
          </a:blip>
          <a:srcRect l="1104" t="33893" r="10296" b="27588"/>
          <a:stretch>
            <a:fillRect/>
          </a:stretch>
        </p:blipFill>
        <p:spPr>
          <a:xfrm>
            <a:off x="623852" y="1022688"/>
            <a:ext cx="3821148" cy="1653178"/>
          </a:xfrm>
          <a:prstGeom prst="rect">
            <a:avLst/>
          </a:prstGeom>
        </p:spPr>
      </p:pic>
      <p:pic>
        <p:nvPicPr>
          <p:cNvPr id="10" name="M7_10uM C12 timeseries">
            <a:hlinkClick r:id="" action="ppaction://media"/>
            <a:extLst>
              <a:ext uri="{FF2B5EF4-FFF2-40B4-BE49-F238E27FC236}">
                <a16:creationId xmlns:a16="http://schemas.microsoft.com/office/drawing/2014/main" id="{78ABC260-C3E1-4834-90C1-853E1B5C478F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 rotWithShape="1">
          <a:blip r:embed="rId17">
            <a:lum contrast="20000"/>
          </a:blip>
          <a:srcRect l="11181" t="29313" r="15811" b="20903"/>
          <a:stretch/>
        </p:blipFill>
        <p:spPr>
          <a:xfrm>
            <a:off x="628024" y="2802007"/>
            <a:ext cx="3844839" cy="1944696"/>
          </a:xfrm>
          <a:prstGeom prst="rect">
            <a:avLst/>
          </a:prstGeom>
        </p:spPr>
      </p:pic>
      <p:pic>
        <p:nvPicPr>
          <p:cNvPr id="11" name="M7 10Um.C12 Zstack-1">
            <a:hlinkClick r:id="" action="ppaction://media"/>
            <a:extLst>
              <a:ext uri="{FF2B5EF4-FFF2-40B4-BE49-F238E27FC236}">
                <a16:creationId xmlns:a16="http://schemas.microsoft.com/office/drawing/2014/main" id="{B74C475A-C367-47F9-9E6F-E63A1EE18968}"/>
              </a:ext>
            </a:extLst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 rotWithShape="1">
          <a:blip r:embed="rId18">
            <a:lum contrast="20000"/>
          </a:blip>
          <a:srcRect l="16309" t="30410" r="10019" b="22512"/>
          <a:stretch>
            <a:fillRect/>
          </a:stretch>
        </p:blipFill>
        <p:spPr>
          <a:xfrm>
            <a:off x="5004053" y="2886252"/>
            <a:ext cx="3870925" cy="1844983"/>
          </a:xfrm>
          <a:prstGeom prst="rect">
            <a:avLst/>
          </a:prstGeom>
        </p:spPr>
      </p:pic>
      <p:pic>
        <p:nvPicPr>
          <p:cNvPr id="14" name="M7 Dmso Zstack2-1">
            <a:hlinkClick r:id="" action="ppaction://media"/>
            <a:extLst>
              <a:ext uri="{FF2B5EF4-FFF2-40B4-BE49-F238E27FC236}">
                <a16:creationId xmlns:a16="http://schemas.microsoft.com/office/drawing/2014/main" id="{647F1005-1A31-4E06-9413-726F88062F3C}"/>
              </a:ext>
            </a:extLst>
          </p:cNvPr>
          <p:cNvPicPr>
            <a:picLocks noChangeAspect="1"/>
          </p:cNvPicPr>
          <p:nvPr>
            <a:vide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 rotWithShape="1">
          <a:blip r:embed="rId19">
            <a:lum contrast="20000"/>
          </a:blip>
          <a:srcRect t="5881" b="30732"/>
          <a:stretch>
            <a:fillRect/>
          </a:stretch>
        </p:blipFill>
        <p:spPr>
          <a:xfrm>
            <a:off x="5033436" y="965355"/>
            <a:ext cx="3841542" cy="177246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7AD2E26-B614-4F74-9C1B-6CDEAA545564}"/>
              </a:ext>
            </a:extLst>
          </p:cNvPr>
          <p:cNvSpPr txBox="1"/>
          <p:nvPr/>
        </p:nvSpPr>
        <p:spPr>
          <a:xfrm>
            <a:off x="0" y="72323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oplasmic reticulum marker (HDEL-GFP)</a:t>
            </a:r>
            <a:endParaRPr lang="en-S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C6488E2D-F025-41CC-BCA8-FC7C73D5E1E9}"/>
              </a:ext>
            </a:extLst>
          </p:cNvPr>
          <p:cNvGrpSpPr/>
          <p:nvPr/>
        </p:nvGrpSpPr>
        <p:grpSpPr>
          <a:xfrm>
            <a:off x="4719316" y="542973"/>
            <a:ext cx="4155665" cy="6115805"/>
            <a:chOff x="339918" y="630948"/>
            <a:chExt cx="4155665" cy="6115805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E10F252-0576-4AFC-B020-A7AC3DCD5BC1}"/>
                </a:ext>
              </a:extLst>
            </p:cNvPr>
            <p:cNvSpPr txBox="1"/>
            <p:nvPr/>
          </p:nvSpPr>
          <p:spPr>
            <a:xfrm>
              <a:off x="647697" y="630948"/>
              <a:ext cx="38478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SG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-stack</a:t>
              </a:r>
              <a:endParaRPr lang="en-S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9C44067-9BA6-4CF1-ABAF-2AA50403BA0D}"/>
                </a:ext>
              </a:extLst>
            </p:cNvPr>
            <p:cNvSpPr txBox="1"/>
            <p:nvPr/>
          </p:nvSpPr>
          <p:spPr>
            <a:xfrm rot="16200000">
              <a:off x="-466639" y="1787246"/>
              <a:ext cx="19208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SG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SE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D15C5F05-3A53-43F4-8C6E-631C93A909DD}"/>
                </a:ext>
              </a:extLst>
            </p:cNvPr>
            <p:cNvSpPr/>
            <p:nvPr/>
          </p:nvSpPr>
          <p:spPr>
            <a:xfrm>
              <a:off x="647700" y="980686"/>
              <a:ext cx="3847883" cy="192089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909EFFC7-76F6-4377-B281-2273D57388A0}"/>
                </a:ext>
              </a:extLst>
            </p:cNvPr>
            <p:cNvSpPr/>
            <p:nvPr/>
          </p:nvSpPr>
          <p:spPr>
            <a:xfrm>
              <a:off x="647700" y="2901584"/>
              <a:ext cx="3847883" cy="192089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577E63EB-946C-45BB-ABA2-77C002FD2D28}"/>
                </a:ext>
              </a:extLst>
            </p:cNvPr>
            <p:cNvSpPr/>
            <p:nvPr/>
          </p:nvSpPr>
          <p:spPr>
            <a:xfrm>
              <a:off x="647698" y="4825855"/>
              <a:ext cx="3847883" cy="192089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0C710C1-2504-4703-8B3C-A0FF78C984C8}"/>
                </a:ext>
              </a:extLst>
            </p:cNvPr>
            <p:cNvSpPr txBox="1"/>
            <p:nvPr/>
          </p:nvSpPr>
          <p:spPr>
            <a:xfrm rot="16200000">
              <a:off x="-466640" y="3708145"/>
              <a:ext cx="19208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SG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 µM C12</a:t>
              </a:r>
              <a:endParaRPr lang="en-SE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6D95E20-4E85-4CE7-8C3E-1842D0C3599A}"/>
                </a:ext>
              </a:extLst>
            </p:cNvPr>
            <p:cNvSpPr txBox="1"/>
            <p:nvPr/>
          </p:nvSpPr>
          <p:spPr>
            <a:xfrm rot="16200000">
              <a:off x="-460300" y="5632415"/>
              <a:ext cx="19208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SG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 µM C12</a:t>
              </a:r>
              <a:endParaRPr lang="en-SE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14B87AC7-DAC8-45D3-B1E6-6D33E208DF49}"/>
                </a:ext>
              </a:extLst>
            </p:cNvPr>
            <p:cNvSpPr/>
            <p:nvPr/>
          </p:nvSpPr>
          <p:spPr>
            <a:xfrm>
              <a:off x="339921" y="980685"/>
              <a:ext cx="307778" cy="192089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C7710B57-6015-49A0-AA3B-D86CA55B93E8}"/>
                </a:ext>
              </a:extLst>
            </p:cNvPr>
            <p:cNvSpPr/>
            <p:nvPr/>
          </p:nvSpPr>
          <p:spPr>
            <a:xfrm>
              <a:off x="339920" y="2901584"/>
              <a:ext cx="307780" cy="192089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D49280C7-0ABF-479C-BF93-7F55D1EB0588}"/>
                </a:ext>
              </a:extLst>
            </p:cNvPr>
            <p:cNvSpPr/>
            <p:nvPr/>
          </p:nvSpPr>
          <p:spPr>
            <a:xfrm>
              <a:off x="339918" y="4825854"/>
              <a:ext cx="309550" cy="192089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4AA09C15-9F4E-412E-B843-19EB740C5726}"/>
                </a:ext>
              </a:extLst>
            </p:cNvPr>
            <p:cNvSpPr/>
            <p:nvPr/>
          </p:nvSpPr>
          <p:spPr>
            <a:xfrm rot="5400000">
              <a:off x="2403883" y="-1115551"/>
              <a:ext cx="338554" cy="384484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 dirty="0"/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223E8456-4A80-44B8-BD03-9E08C571AAE7}"/>
              </a:ext>
            </a:extLst>
          </p:cNvPr>
          <p:cNvSpPr txBox="1"/>
          <p:nvPr/>
        </p:nvSpPr>
        <p:spPr>
          <a:xfrm>
            <a:off x="306689" y="491261"/>
            <a:ext cx="3141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93212C5-F3BE-4A5E-9CD2-9B6661221E13}"/>
              </a:ext>
            </a:extLst>
          </p:cNvPr>
          <p:cNvSpPr txBox="1"/>
          <p:nvPr/>
        </p:nvSpPr>
        <p:spPr>
          <a:xfrm>
            <a:off x="4709937" y="518839"/>
            <a:ext cx="3141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SE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6BD0C54-395B-48BE-979A-51BECE8FC9BA}"/>
              </a:ext>
            </a:extLst>
          </p:cNvPr>
          <p:cNvCxnSpPr>
            <a:cxnSpLocks/>
          </p:cNvCxnSpPr>
          <p:nvPr/>
        </p:nvCxnSpPr>
        <p:spPr>
          <a:xfrm rot="16200000">
            <a:off x="1035131" y="2385481"/>
            <a:ext cx="0" cy="597724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4AF6A22E-ED55-4336-B5DB-02D74FEA0A8E}"/>
              </a:ext>
            </a:extLst>
          </p:cNvPr>
          <p:cNvCxnSpPr>
            <a:cxnSpLocks/>
          </p:cNvCxnSpPr>
          <p:nvPr/>
        </p:nvCxnSpPr>
        <p:spPr>
          <a:xfrm rot="16200000">
            <a:off x="990599" y="4353790"/>
            <a:ext cx="0" cy="50866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5F13DFDD-F67C-495D-A53E-768DEB9C5824}"/>
              </a:ext>
            </a:extLst>
          </p:cNvPr>
          <p:cNvCxnSpPr>
            <a:cxnSpLocks/>
          </p:cNvCxnSpPr>
          <p:nvPr/>
        </p:nvCxnSpPr>
        <p:spPr>
          <a:xfrm rot="16200000" flipV="1">
            <a:off x="5385458" y="2454794"/>
            <a:ext cx="0" cy="493386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50C29B2A-E3FA-4AB2-8248-3B2E198A6648}"/>
              </a:ext>
            </a:extLst>
          </p:cNvPr>
          <p:cNvCxnSpPr>
            <a:cxnSpLocks/>
          </p:cNvCxnSpPr>
          <p:nvPr/>
        </p:nvCxnSpPr>
        <p:spPr>
          <a:xfrm rot="16200000" flipV="1">
            <a:off x="5390621" y="4356265"/>
            <a:ext cx="0" cy="503712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43FE37E5-00F8-4CCC-A272-FFD3BD5977F0}"/>
              </a:ext>
            </a:extLst>
          </p:cNvPr>
          <p:cNvCxnSpPr>
            <a:cxnSpLocks/>
          </p:cNvCxnSpPr>
          <p:nvPr/>
        </p:nvCxnSpPr>
        <p:spPr>
          <a:xfrm rot="16200000" flipV="1">
            <a:off x="976991" y="6297881"/>
            <a:ext cx="0" cy="481444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446B0502-2BE3-486C-BC1D-282FB84B9010}"/>
              </a:ext>
            </a:extLst>
          </p:cNvPr>
          <p:cNvCxnSpPr>
            <a:cxnSpLocks/>
          </p:cNvCxnSpPr>
          <p:nvPr/>
        </p:nvCxnSpPr>
        <p:spPr>
          <a:xfrm rot="16200000">
            <a:off x="5407568" y="6265470"/>
            <a:ext cx="0" cy="537606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5205DD89-3A91-47F4-8045-42CDF0213E04}"/>
              </a:ext>
            </a:extLst>
          </p:cNvPr>
          <p:cNvGrpSpPr/>
          <p:nvPr/>
        </p:nvGrpSpPr>
        <p:grpSpPr>
          <a:xfrm>
            <a:off x="313032" y="542973"/>
            <a:ext cx="4155663" cy="6115805"/>
            <a:chOff x="313032" y="542973"/>
            <a:chExt cx="4155663" cy="6115805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798B7FE6-C518-4643-9215-41071A172C9D}"/>
                </a:ext>
              </a:extLst>
            </p:cNvPr>
            <p:cNvGrpSpPr/>
            <p:nvPr/>
          </p:nvGrpSpPr>
          <p:grpSpPr>
            <a:xfrm>
              <a:off x="313032" y="542973"/>
              <a:ext cx="4155663" cy="6115805"/>
              <a:chOff x="339920" y="630948"/>
              <a:chExt cx="4155663" cy="6115805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5DF64C90-E14B-4CA7-AC79-9EAAF99DDC50}"/>
                  </a:ext>
                </a:extLst>
              </p:cNvPr>
              <p:cNvSpPr txBox="1"/>
              <p:nvPr/>
            </p:nvSpPr>
            <p:spPr>
              <a:xfrm>
                <a:off x="647697" y="630948"/>
                <a:ext cx="38478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G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series</a:t>
                </a:r>
                <a:endParaRPr lang="en-SE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2EB443C-B579-4C41-ABFA-1DC90C77A1C9}"/>
                  </a:ext>
                </a:extLst>
              </p:cNvPr>
              <p:cNvSpPr txBox="1"/>
              <p:nvPr/>
            </p:nvSpPr>
            <p:spPr>
              <a:xfrm rot="16200000">
                <a:off x="-466639" y="1787246"/>
                <a:ext cx="19208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G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  <a:endParaRPr lang="en-SE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FDEF1301-3E4E-4F9C-90F6-51A9BF21D9C5}"/>
                  </a:ext>
                </a:extLst>
              </p:cNvPr>
              <p:cNvSpPr/>
              <p:nvPr/>
            </p:nvSpPr>
            <p:spPr>
              <a:xfrm>
                <a:off x="647700" y="980686"/>
                <a:ext cx="3847883" cy="192089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49AD5E02-9D15-4424-BCE2-91A0B20A7667}"/>
                  </a:ext>
                </a:extLst>
              </p:cNvPr>
              <p:cNvSpPr/>
              <p:nvPr/>
            </p:nvSpPr>
            <p:spPr>
              <a:xfrm>
                <a:off x="647700" y="2901584"/>
                <a:ext cx="3847883" cy="192089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59E1DBA1-1CEA-4216-A564-D079AAA3B0F8}"/>
                  </a:ext>
                </a:extLst>
              </p:cNvPr>
              <p:cNvSpPr/>
              <p:nvPr/>
            </p:nvSpPr>
            <p:spPr>
              <a:xfrm>
                <a:off x="647698" y="4825855"/>
                <a:ext cx="3847883" cy="192089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83AD09DC-F041-455F-8946-0468E951D83E}"/>
                  </a:ext>
                </a:extLst>
              </p:cNvPr>
              <p:cNvSpPr txBox="1"/>
              <p:nvPr/>
            </p:nvSpPr>
            <p:spPr>
              <a:xfrm rot="16200000">
                <a:off x="-466640" y="3708145"/>
                <a:ext cx="19208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G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µM C12</a:t>
                </a:r>
                <a:endParaRPr lang="en-SE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9FAE3A21-B61B-48D6-91C8-EC28D3940686}"/>
                  </a:ext>
                </a:extLst>
              </p:cNvPr>
              <p:cNvSpPr txBox="1"/>
              <p:nvPr/>
            </p:nvSpPr>
            <p:spPr>
              <a:xfrm rot="16200000">
                <a:off x="-460300" y="5632415"/>
                <a:ext cx="19208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G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0 µM C12</a:t>
                </a:r>
                <a:endParaRPr lang="en-SE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4F5D6262-0954-4886-A436-9FA4705D5111}"/>
                  </a:ext>
                </a:extLst>
              </p:cNvPr>
              <p:cNvSpPr/>
              <p:nvPr/>
            </p:nvSpPr>
            <p:spPr>
              <a:xfrm>
                <a:off x="339921" y="980685"/>
                <a:ext cx="307778" cy="192089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95DFDDFA-1BC8-497D-9F6B-0BB61FB2920D}"/>
                  </a:ext>
                </a:extLst>
              </p:cNvPr>
              <p:cNvSpPr/>
              <p:nvPr/>
            </p:nvSpPr>
            <p:spPr>
              <a:xfrm>
                <a:off x="339920" y="2901584"/>
                <a:ext cx="307780" cy="192089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/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0AD2100F-ADA5-4725-8FFF-7050F797C637}"/>
                  </a:ext>
                </a:extLst>
              </p:cNvPr>
              <p:cNvSpPr/>
              <p:nvPr/>
            </p:nvSpPr>
            <p:spPr>
              <a:xfrm rot="5400000">
                <a:off x="2403883" y="-1115551"/>
                <a:ext cx="338554" cy="3844840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SE" dirty="0"/>
              </a:p>
            </p:txBody>
          </p:sp>
        </p:grp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08D0C8C5-9BD5-437A-A1CD-2FEFF3F96317}"/>
                </a:ext>
              </a:extLst>
            </p:cNvPr>
            <p:cNvSpPr/>
            <p:nvPr/>
          </p:nvSpPr>
          <p:spPr>
            <a:xfrm>
              <a:off x="314803" y="4737879"/>
              <a:ext cx="309550" cy="192089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E"/>
            </a:p>
          </p:txBody>
        </p:sp>
      </p:grpSp>
    </p:spTree>
    <p:extLst>
      <p:ext uri="{BB962C8B-B14F-4D97-AF65-F5344CB8AC3E}">
        <p14:creationId xmlns:p14="http://schemas.microsoft.com/office/powerpoint/2010/main" val="36889350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4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4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8"/>
                  </p:tgtEl>
                </p:cond>
              </p:nextCondLst>
            </p:seq>
            <p:video>
              <p:cMediaNode vol="80000">
                <p:cTn id="25" repeatCount="indefinite" fill="hold" display="0">
                  <p:stCondLst>
                    <p:cond delay="indefinite"/>
                  </p:stCondLst>
                </p:cTn>
                <p:tgtEl>
                  <p:spTgt spid="48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4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4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9"/>
                  </p:tgtEl>
                </p:cond>
              </p:nextCondLst>
            </p:seq>
            <p:video>
              <p:cMediaNode vol="80000">
                <p:cTn id="31" repeatCount="indefinite" fill="hold" display="0">
                  <p:stCondLst>
                    <p:cond delay="indefinite"/>
                  </p:stCondLst>
                </p:cTn>
                <p:tgtEl>
                  <p:spTgt spid="49"/>
                </p:tgtEl>
              </p:cMediaNode>
            </p:video>
            <p:seq concurrent="1" nextAc="seek">
              <p:cTn id="32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3" fill="hold">
                      <p:stCondLst>
                        <p:cond delay="0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6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37" repeatCount="indefinite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</Words>
  <Application>Microsoft Office PowerPoint</Application>
  <PresentationFormat>On-screen Show (4:3)</PresentationFormat>
  <Paragraphs>11</Paragraphs>
  <Slides>1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rian Dauphinee</dc:creator>
  <cp:lastModifiedBy>Adrian Dauphinee</cp:lastModifiedBy>
  <cp:revision>14</cp:revision>
  <dcterms:created xsi:type="dcterms:W3CDTF">2018-12-07T11:47:05Z</dcterms:created>
  <dcterms:modified xsi:type="dcterms:W3CDTF">2019-03-05T16:39:52Z</dcterms:modified>
</cp:coreProperties>
</file>